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1541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430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360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980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310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7167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763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9325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9212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935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99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204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6A9DE-8FEE-4BFD-807E-6A0956E20B81}" type="datetimeFigureOut">
              <a:rPr lang="en-GB" smtClean="0"/>
              <a:t>26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44B02-B412-48EC-B3DC-C428B7849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1925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wmeng\Downloads\genetcicorrlationpublication\revise1\revision2\revision3\revision4\ejhg\Supplementary figure 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32862"/>
            <a:ext cx="6768752" cy="55563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83568" y="5589240"/>
            <a:ext cx="77768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: The heatmap of the genetic correlations among eight pain phenotypes (UK Biobank) and migraine (</a:t>
            </a:r>
            <a:r>
              <a:rPr lang="en-GB" dirty="0" err="1"/>
              <a:t>23andMe</a:t>
            </a:r>
            <a:r>
              <a:rPr lang="en-GB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53411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onymous</dc:creator>
  <cp:lastModifiedBy>Weihua Meng (Staff)</cp:lastModifiedBy>
  <cp:revision>2</cp:revision>
  <dcterms:created xsi:type="dcterms:W3CDTF">2019-07-24T15:03:43Z</dcterms:created>
  <dcterms:modified xsi:type="dcterms:W3CDTF">2019-07-26T10:12:43Z</dcterms:modified>
</cp:coreProperties>
</file>